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67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50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082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092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774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9264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9873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8917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888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4046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144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0585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3CA8E-CB1B-4514-8F08-C1E83FE653DE}" type="datetimeFigureOut">
              <a:rPr lang="en-GB" smtClean="0"/>
              <a:t>03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E41D6-572C-4CA1-AE02-6ECBCF1E1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7794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itle 1"/>
          <p:cNvSpPr txBox="1">
            <a:spLocks/>
          </p:cNvSpPr>
          <p:nvPr/>
        </p:nvSpPr>
        <p:spPr>
          <a:xfrm rot="16200000">
            <a:off x="-739321" y="2803190"/>
            <a:ext cx="1852583" cy="344320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d29_MN</a:t>
            </a:r>
            <a:endParaRPr lang="en-GB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402779" y="-56467"/>
            <a:ext cx="1320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stin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67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6284567" y="-56467"/>
            <a:ext cx="161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133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x2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20991" y="2222323"/>
            <a:ext cx="2360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  <a:r>
              <a:rPr lang="en-US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ZD9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402778" y="2222323"/>
            <a:ext cx="982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AP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284566" y="2222323"/>
            <a:ext cx="1306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IITubulin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20991" y="4512256"/>
            <a:ext cx="1766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200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EA4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ig2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20992" y="-56467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506340" y="4793326"/>
            <a:ext cx="2498755" cy="769441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stin</a:t>
            </a:r>
            <a:r>
              <a:rPr lang="en-US" sz="1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 	</a:t>
            </a:r>
            <a:r>
              <a:rPr 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	</a:t>
            </a:r>
            <a:r>
              <a:rPr lang="en-US" sz="10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33</a:t>
            </a:r>
          </a:p>
          <a:p>
            <a:r>
              <a:rPr lang="en-US" sz="10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2	</a:t>
            </a:r>
            <a:r>
              <a:rPr lang="en-US" sz="1000" dirty="0">
                <a:solidFill>
                  <a:srgbClr val="92D05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	</a:t>
            </a:r>
            <a:r>
              <a:rPr lang="en-US" sz="10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GB" sz="10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ZD9</a:t>
            </a:r>
          </a:p>
          <a:p>
            <a:r>
              <a:rPr lang="en-US" sz="10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P	</a:t>
            </a:r>
            <a:r>
              <a:rPr lang="en-US" sz="10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IITubul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000" dirty="0">
                <a:solidFill>
                  <a:srgbClr val="CC00CC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GB" sz="1000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EA4</a:t>
            </a:r>
          </a:p>
          <a:p>
            <a:r>
              <a:rPr lang="en-US" sz="10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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g2</a:t>
            </a:r>
          </a:p>
          <a:p>
            <a:endParaRPr lang="en-GB" sz="10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8569643" y="4516349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8664928" y="4718770"/>
            <a:ext cx="410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Group 10"/>
          <p:cNvGrpSpPr/>
          <p:nvPr/>
        </p:nvGrpSpPr>
        <p:grpSpPr>
          <a:xfrm>
            <a:off x="6485780" y="5961327"/>
            <a:ext cx="856838" cy="826764"/>
            <a:chOff x="6949897" y="5464619"/>
            <a:chExt cx="856838" cy="826764"/>
          </a:xfrm>
        </p:grpSpPr>
        <p:sp>
          <p:nvSpPr>
            <p:cNvPr id="44" name="Rectangle 43"/>
            <p:cNvSpPr/>
            <p:nvPr/>
          </p:nvSpPr>
          <p:spPr>
            <a:xfrm>
              <a:off x="7198954" y="5464619"/>
              <a:ext cx="558010" cy="6038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>
              <a:off x="7198954" y="6103087"/>
              <a:ext cx="55801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 flipV="1">
              <a:off x="7151714" y="5464619"/>
              <a:ext cx="0" cy="60381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7149183" y="6045162"/>
              <a:ext cx="65755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7.42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µ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744232" y="5670284"/>
              <a:ext cx="65755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4.75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µ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6409414" y="5418523"/>
            <a:ext cx="13292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MapInfo Cartographic" panose="05050102010607020607" pitchFamily="18" charset="2"/>
              </a:rPr>
              <a:t>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marker detected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292848" y="5985409"/>
            <a:ext cx="132475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mensions of a single sub-area within the grid  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409414" y="4741653"/>
            <a:ext cx="2595680" cy="9230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/>
          <p:cNvSpPr/>
          <p:nvPr/>
        </p:nvSpPr>
        <p:spPr>
          <a:xfrm>
            <a:off x="6413201" y="5828557"/>
            <a:ext cx="2595680" cy="9230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" name="Straight Connector 6"/>
          <p:cNvCxnSpPr/>
          <p:nvPr/>
        </p:nvCxnSpPr>
        <p:spPr>
          <a:xfrm>
            <a:off x="413084" y="160186"/>
            <a:ext cx="0" cy="66978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Picture 4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600" y="162000"/>
            <a:ext cx="2832000" cy="21240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3608" y="162000"/>
            <a:ext cx="2832000" cy="212400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616" y="162000"/>
            <a:ext cx="2832000" cy="212400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600" y="2444400"/>
            <a:ext cx="2832000" cy="2124000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3608" y="2444400"/>
            <a:ext cx="2832000" cy="212400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616" y="2444400"/>
            <a:ext cx="2832000" cy="2124000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99" y="4723200"/>
            <a:ext cx="2832000" cy="2124000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07792" y="4726800"/>
            <a:ext cx="2827398" cy="212400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3503362" y="4512256"/>
            <a:ext cx="1766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grid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1705" y="3586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251351" y="44937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913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</TotalTime>
  <Words>31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apInfo Cartographic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MA MOHAMAD *************** HUSSAIN</dc:creator>
  <cp:lastModifiedBy>DEEMA MOHAMAD *************** HUSSAIN</cp:lastModifiedBy>
  <cp:revision>22</cp:revision>
  <dcterms:created xsi:type="dcterms:W3CDTF">2016-07-28T09:26:46Z</dcterms:created>
  <dcterms:modified xsi:type="dcterms:W3CDTF">2018-05-03T09:34:59Z</dcterms:modified>
</cp:coreProperties>
</file>